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48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3855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6937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8520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289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0266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4537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3933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5058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7636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0484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784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70425-F8F8-492B-85A5-CD6DBD5F3DA7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10374-473E-4C36-BC95-F3452CA0A68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319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"/>
          <p:cNvSpPr txBox="1">
            <a:spLocks noChangeArrowheads="1"/>
          </p:cNvSpPr>
          <p:nvPr/>
        </p:nvSpPr>
        <p:spPr bwMode="auto">
          <a:xfrm>
            <a:off x="62752" y="141981"/>
            <a:ext cx="12030635" cy="6545221"/>
          </a:xfrm>
          <a:prstGeom prst="rect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38" name="组合 37"/>
          <p:cNvGrpSpPr/>
          <p:nvPr/>
        </p:nvGrpSpPr>
        <p:grpSpPr>
          <a:xfrm>
            <a:off x="410648" y="785036"/>
            <a:ext cx="11304837" cy="5693087"/>
            <a:chOff x="526321" y="859527"/>
            <a:chExt cx="9608510" cy="5414257"/>
          </a:xfrm>
        </p:grpSpPr>
        <p:sp>
          <p:nvSpPr>
            <p:cNvPr id="20" name="文本框 2"/>
            <p:cNvSpPr txBox="1">
              <a:spLocks noChangeArrowheads="1"/>
            </p:cNvSpPr>
            <p:nvPr/>
          </p:nvSpPr>
          <p:spPr bwMode="auto">
            <a:xfrm>
              <a:off x="803945" y="859527"/>
              <a:ext cx="2529681" cy="84817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600" b="1" dirty="0" smtClean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64</a:t>
              </a:r>
              <a:r>
                <a:rPr kumimoji="0" lang="en-US" altLang="zh-CN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atients from 19 hospitals </a:t>
              </a:r>
              <a:r>
                <a:rPr kumimoji="0" lang="en-US" altLang="zh-CN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in </a:t>
              </a:r>
              <a:r>
                <a:rPr lang="en-US" altLang="zh-CN" sz="1600" b="1" dirty="0">
                  <a:latin typeface="Calibri" panose="020F0502020204030204" pitchFamily="34" charset="0"/>
                  <a:cs typeface="Times New Roman" panose="02020603050405020304" pitchFamily="18" charset="0"/>
                </a:rPr>
                <a:t>China between Jan 1999 and Jun 2008 in the retrospective study</a:t>
              </a:r>
              <a:endParaRPr kumimoji="0" lang="en-US" altLang="zh-CN" sz="3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文本框 5"/>
            <p:cNvSpPr txBox="1">
              <a:spLocks noChangeArrowheads="1"/>
            </p:cNvSpPr>
            <p:nvPr/>
          </p:nvSpPr>
          <p:spPr bwMode="auto">
            <a:xfrm>
              <a:off x="526321" y="1977267"/>
              <a:ext cx="2020807" cy="2075808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0 </a:t>
              </a: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ere excluded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9 </a:t>
              </a: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ad different </a:t>
              </a:r>
              <a:r>
                <a:rPr kumimoji="0" lang="en-US" altLang="zh-CN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ubtype </a:t>
              </a: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of</a:t>
              </a:r>
              <a:r>
                <a:rPr kumimoji="0" lang="en-US" altLang="zh-CN" sz="1600" b="1" i="0" u="none" strike="noStrike" cap="none" normalizeH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ymphoma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0</a:t>
              </a:r>
              <a:r>
                <a:rPr kumimoji="0" lang="en-US" altLang="zh-CN" sz="1600" b="1" i="0" u="none" strike="noStrike" cap="none" normalizeH="0" baseline="0" dirty="0" smtClean="0" bmk="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600" b="1" i="0" u="none" strike="noStrike" cap="none" normalizeH="0" baseline="0" dirty="0" bmk="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ad incomplete follow-up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6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1 </a:t>
              </a: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inadequate quality </a:t>
              </a:r>
              <a:r>
                <a:rPr lang="en-US" altLang="zh-CN" sz="1600" b="1" dirty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of definitive diagnosis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600" b="1" dirty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600" b="1" dirty="0" smtClean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 </a:t>
              </a:r>
              <a:r>
                <a:rPr lang="en-US" altLang="zh-CN" sz="1600" b="1" dirty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received </a:t>
              </a:r>
              <a:r>
                <a:rPr lang="en-US" altLang="zh-CN" sz="1600" b="1" dirty="0" smtClean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no treatment </a:t>
              </a:r>
              <a:r>
                <a:rPr lang="en-US" altLang="zh-CN" sz="1600" dirty="0"/>
                <a:t/>
              </a:r>
              <a:br>
                <a:rPr lang="en-US" altLang="zh-CN" sz="1600" dirty="0"/>
              </a:b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endPara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文本框 9"/>
            <p:cNvSpPr txBox="1">
              <a:spLocks noChangeArrowheads="1"/>
            </p:cNvSpPr>
            <p:nvPr/>
          </p:nvSpPr>
          <p:spPr bwMode="auto">
            <a:xfrm>
              <a:off x="2361089" y="5560547"/>
              <a:ext cx="2559156" cy="713237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168 patients were used to develop the new staging system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文本框 11"/>
            <p:cNvSpPr txBox="1">
              <a:spLocks noChangeArrowheads="1"/>
            </p:cNvSpPr>
            <p:nvPr/>
          </p:nvSpPr>
          <p:spPr bwMode="auto">
            <a:xfrm>
              <a:off x="6712631" y="859527"/>
              <a:ext cx="2566750" cy="842686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033 patients from China</a:t>
              </a:r>
              <a:r>
                <a:rPr lang="en-US" altLang="zh-CN" sz="1600" b="1" dirty="0"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, </a:t>
              </a: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South Korea and </a:t>
              </a:r>
              <a:r>
                <a:rPr lang="en-US" altLang="zh-CN" sz="16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Singapore between </a:t>
              </a:r>
              <a:r>
                <a:rPr lang="en-US" altLang="zh-CN" sz="1600" b="1" dirty="0">
                  <a:latin typeface="Calibri" panose="020F0502020204030204" pitchFamily="34" charset="0"/>
                  <a:cs typeface="Times New Roman" panose="02020603050405020304" pitchFamily="18" charset="0"/>
                </a:rPr>
                <a:t>Jan 2010 </a:t>
              </a:r>
              <a:r>
                <a:rPr lang="en-US" altLang="zh-CN" sz="1600" b="1" dirty="0" smtClean="0">
                  <a:latin typeface="Calibri" panose="020F0502020204030204" pitchFamily="34" charset="0"/>
                  <a:cs typeface="Times New Roman" panose="02020603050405020304" pitchFamily="18" charset="0"/>
                </a:rPr>
                <a:t>and </a:t>
              </a:r>
              <a:r>
                <a:rPr lang="en-US" altLang="zh-CN" sz="1600" b="1" dirty="0">
                  <a:latin typeface="Calibri" panose="020F0502020204030204" pitchFamily="34" charset="0"/>
                  <a:cs typeface="Times New Roman" panose="02020603050405020304" pitchFamily="18" charset="0"/>
                </a:rPr>
                <a:t>Dec 2017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文本框 12"/>
            <p:cNvSpPr txBox="1">
              <a:spLocks noChangeArrowheads="1"/>
            </p:cNvSpPr>
            <p:nvPr/>
          </p:nvSpPr>
          <p:spPr bwMode="auto">
            <a:xfrm>
              <a:off x="7837337" y="2627034"/>
              <a:ext cx="2297494" cy="1466521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48 were excluded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21 had different subtypes of lymphoma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14 had incomplete follow-up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13 had missing pretreatment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haracteristics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文本框 17"/>
            <p:cNvSpPr txBox="1">
              <a:spLocks noChangeArrowheads="1"/>
            </p:cNvSpPr>
            <p:nvPr/>
          </p:nvSpPr>
          <p:spPr bwMode="auto">
            <a:xfrm>
              <a:off x="6712631" y="5560547"/>
              <a:ext cx="2463319" cy="713237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985 patients were used to validate the new staging system</a:t>
              </a:r>
              <a:endPara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0" name="Rectangle 32"/>
          <p:cNvSpPr>
            <a:spLocks noChangeArrowheads="1"/>
          </p:cNvSpPr>
          <p:nvPr/>
        </p:nvSpPr>
        <p:spPr bwMode="auto">
          <a:xfrm>
            <a:off x="152400" y="16427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31" name="Rectangle 36"/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32" name="Rectangle 40"/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33" name="Rectangle 42"/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37" name="文本框 36"/>
          <p:cNvSpPr txBox="1"/>
          <p:nvPr/>
        </p:nvSpPr>
        <p:spPr>
          <a:xfrm>
            <a:off x="-12957" y="109344"/>
            <a:ext cx="2824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ry Figure 1</a:t>
            </a:r>
            <a:endParaRPr lang="zh-CN" altLang="en-US" dirty="0"/>
          </a:p>
        </p:txBody>
      </p:sp>
      <p:cxnSp>
        <p:nvCxnSpPr>
          <p:cNvPr id="5" name="直接箭头连接符 4"/>
          <p:cNvCxnSpPr/>
          <p:nvPr/>
        </p:nvCxnSpPr>
        <p:spPr>
          <a:xfrm>
            <a:off x="3169702" y="1740015"/>
            <a:ext cx="16071" cy="28205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8466032" y="1705302"/>
            <a:ext cx="0" cy="39539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 flipV="1">
            <a:off x="8466032" y="3414591"/>
            <a:ext cx="521004" cy="81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接箭头连接符 5"/>
          <p:cNvCxnSpPr/>
          <p:nvPr/>
        </p:nvCxnSpPr>
        <p:spPr>
          <a:xfrm flipH="1">
            <a:off x="2811502" y="3084112"/>
            <a:ext cx="3582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2"/>
          <p:cNvSpPr txBox="1">
            <a:spLocks noChangeArrowheads="1"/>
          </p:cNvSpPr>
          <p:nvPr/>
        </p:nvSpPr>
        <p:spPr bwMode="auto">
          <a:xfrm>
            <a:off x="4057791" y="785035"/>
            <a:ext cx="2976282" cy="887630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304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atients from 19 hospitals in </a:t>
            </a:r>
            <a:r>
              <a:rPr lang="en-US" altLang="zh-CN" sz="1600" b="1" dirty="0">
                <a:latin typeface="Calibri" panose="020F0502020204030204" pitchFamily="34" charset="0"/>
                <a:cs typeface="Times New Roman" panose="02020603050405020304" pitchFamily="18" charset="0"/>
              </a:rPr>
              <a:t>China between Jul 2008 and Dec </a:t>
            </a:r>
            <a:r>
              <a:rPr lang="en-US" altLang="zh-CN" sz="1600" b="1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2012 in </a:t>
            </a:r>
            <a:r>
              <a:rPr lang="en-US" altLang="zh-CN" sz="1600" b="1" dirty="0">
                <a:latin typeface="Calibri" panose="020F0502020204030204" pitchFamily="34" charset="0"/>
                <a:cs typeface="Times New Roman" panose="02020603050405020304" pitchFamily="18" charset="0"/>
              </a:rPr>
              <a:t>the prospective study</a:t>
            </a:r>
            <a:endParaRPr kumimoji="0" lang="en-US" altLang="zh-CN" sz="3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35" name="直接箭头连接符 34"/>
          <p:cNvCxnSpPr/>
          <p:nvPr/>
        </p:nvCxnSpPr>
        <p:spPr>
          <a:xfrm>
            <a:off x="4787153" y="1705302"/>
            <a:ext cx="23536" cy="39539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文本框 2"/>
          <p:cNvSpPr txBox="1">
            <a:spLocks noChangeArrowheads="1"/>
          </p:cNvSpPr>
          <p:nvPr/>
        </p:nvSpPr>
        <p:spPr bwMode="auto">
          <a:xfrm>
            <a:off x="1217053" y="4595027"/>
            <a:ext cx="2976282" cy="684954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 smtClean="0"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864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6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atients </a:t>
            </a:r>
            <a:r>
              <a:rPr lang="en-US" altLang="zh-CN" sz="1600" b="1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en-US" altLang="zh-CN" sz="1600" b="1" dirty="0">
                <a:latin typeface="Calibri" panose="020F0502020204030204" pitchFamily="34" charset="0"/>
                <a:cs typeface="Times New Roman" panose="02020603050405020304" pitchFamily="18" charset="0"/>
              </a:rPr>
              <a:t>the retrospective</a:t>
            </a:r>
            <a:r>
              <a:rPr lang="en-US" altLang="zh-CN" sz="1600" b="1" dirty="0" smtClean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600" b="1" dirty="0">
                <a:latin typeface="Calibri" panose="020F0502020204030204" pitchFamily="34" charset="0"/>
                <a:cs typeface="Times New Roman" panose="02020603050405020304" pitchFamily="18" charset="0"/>
              </a:rPr>
              <a:t>study</a:t>
            </a:r>
            <a:endParaRPr kumimoji="0" lang="en-US" altLang="zh-CN" sz="36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483684" y="383067"/>
            <a:ext cx="5072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46" name="文本框 45"/>
          <p:cNvSpPr txBox="1"/>
          <p:nvPr/>
        </p:nvSpPr>
        <p:spPr>
          <a:xfrm>
            <a:off x="7359315" y="403568"/>
            <a:ext cx="5032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cxnSp>
        <p:nvCxnSpPr>
          <p:cNvPr id="8" name="直接箭头连接符 7"/>
          <p:cNvCxnSpPr/>
          <p:nvPr/>
        </p:nvCxnSpPr>
        <p:spPr>
          <a:xfrm>
            <a:off x="3185773" y="5325035"/>
            <a:ext cx="0" cy="3851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30216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528034" y="517932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6020702" y="512768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6971135"/>
              </p:ext>
            </p:extLst>
          </p:nvPr>
        </p:nvGraphicFramePr>
        <p:xfrm>
          <a:off x="51006" y="5575567"/>
          <a:ext cx="4646499" cy="117342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353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0642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8610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2487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664839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611008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tage 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0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3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5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3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6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4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tage 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1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tage I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65568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Stage IV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1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10" name="表格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3457798"/>
              </p:ext>
            </p:extLst>
          </p:nvPr>
        </p:nvGraphicFramePr>
        <p:xfrm>
          <a:off x="5658874" y="5595378"/>
          <a:ext cx="4646499" cy="117342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353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0642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8610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2487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664839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611008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2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7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5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3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0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3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1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1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6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9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65568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V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6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317" y="804538"/>
            <a:ext cx="5991225" cy="48006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73258" y="804538"/>
            <a:ext cx="5991225" cy="48006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286870" y="143436"/>
            <a:ext cx="2406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l Figure </a:t>
            </a:r>
            <a:r>
              <a:rPr lang="en-US" altLang="zh-CN" dirty="0" smtClean="0"/>
              <a:t>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06374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536999" y="346024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6694868" y="377402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372136"/>
              </p:ext>
            </p:extLst>
          </p:nvPr>
        </p:nvGraphicFramePr>
        <p:xfrm>
          <a:off x="68936" y="5441100"/>
          <a:ext cx="4646499" cy="117342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353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0642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8610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2487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664839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611008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0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65568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V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24631446"/>
              </p:ext>
            </p:extLst>
          </p:nvPr>
        </p:nvGraphicFramePr>
        <p:xfrm>
          <a:off x="6200775" y="5515956"/>
          <a:ext cx="4646499" cy="117342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353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0642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8610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24872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664839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94856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611008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9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65568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V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647" y="715356"/>
            <a:ext cx="5991225" cy="48006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0775" y="715356"/>
            <a:ext cx="5991225" cy="480060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51009" y="8070"/>
            <a:ext cx="24505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plemental Figure </a:t>
            </a:r>
            <a:r>
              <a:rPr lang="en-US" altLang="zh-CN" dirty="0" smtClean="0"/>
              <a:t>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09549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380" y="822514"/>
            <a:ext cx="5991225" cy="48006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0" y="0"/>
            <a:ext cx="241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upplementary Figure 3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868697" y="517932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0938833"/>
              </p:ext>
            </p:extLst>
          </p:nvPr>
        </p:nvGraphicFramePr>
        <p:xfrm>
          <a:off x="143436" y="5485917"/>
          <a:ext cx="4897512" cy="108198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775164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51130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9176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29934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67125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600594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600594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616903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Low-risk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54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42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3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0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4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1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7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intermediate-risk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7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1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7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5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3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High-risk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7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4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</a:tbl>
          </a:graphicData>
        </a:graphic>
      </p:graphicFrame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12516" y="822514"/>
            <a:ext cx="5991225" cy="480060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6501329" y="512768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graphicFrame>
        <p:nvGraphicFramePr>
          <p:cNvPr id="13" name="表格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836426"/>
              </p:ext>
            </p:extLst>
          </p:nvPr>
        </p:nvGraphicFramePr>
        <p:xfrm>
          <a:off x="5949762" y="5508796"/>
          <a:ext cx="4691322" cy="117342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8974"/>
                <a:gridCol w="511307"/>
                <a:gridCol w="591764"/>
                <a:gridCol w="529934"/>
                <a:gridCol w="671252"/>
                <a:gridCol w="600594"/>
                <a:gridCol w="600594"/>
                <a:gridCol w="616903"/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7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4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1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9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0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II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65568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Stage IV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9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240079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502114" y="316082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6632116" y="317284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8" name="文本框 36"/>
          <p:cNvSpPr txBox="1"/>
          <p:nvPr/>
        </p:nvSpPr>
        <p:spPr>
          <a:xfrm>
            <a:off x="97211" y="0"/>
            <a:ext cx="2511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/>
              <a:t>Supplementary Figure 4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893" y="619923"/>
            <a:ext cx="5991225" cy="48006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7048" y="686616"/>
            <a:ext cx="5991225" cy="4800600"/>
          </a:xfrm>
          <a:prstGeom prst="rect">
            <a:avLst/>
          </a:prstGeom>
        </p:spPr>
      </p:pic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8922164"/>
              </p:ext>
            </p:extLst>
          </p:nvPr>
        </p:nvGraphicFramePr>
        <p:xfrm>
          <a:off x="177893" y="5313002"/>
          <a:ext cx="4646499" cy="71622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3538"/>
                <a:gridCol w="506421"/>
                <a:gridCol w="586109"/>
                <a:gridCol w="524872"/>
                <a:gridCol w="664839"/>
                <a:gridCol w="594856"/>
                <a:gridCol w="594856"/>
                <a:gridCol w="611008"/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R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1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9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RT+C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0" name="表格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0609751"/>
              </p:ext>
            </p:extLst>
          </p:nvPr>
        </p:nvGraphicFramePr>
        <p:xfrm>
          <a:off x="6169119" y="5420523"/>
          <a:ext cx="4678174" cy="144774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7380"/>
                <a:gridCol w="509873"/>
                <a:gridCol w="590105"/>
                <a:gridCol w="528450"/>
                <a:gridCol w="669371"/>
                <a:gridCol w="598911"/>
                <a:gridCol w="598911"/>
                <a:gridCol w="615173"/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R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CT+CCRT/R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CCR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5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65568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CCRT+C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716137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554928" y="320905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6710252" y="297556"/>
            <a:ext cx="1403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377" y="645412"/>
            <a:ext cx="5991225" cy="48006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0775" y="645412"/>
            <a:ext cx="5991225" cy="4800600"/>
          </a:xfrm>
          <a:prstGeom prst="rect">
            <a:avLst/>
          </a:prstGeom>
        </p:spPr>
      </p:pic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7199293"/>
              </p:ext>
            </p:extLst>
          </p:nvPr>
        </p:nvGraphicFramePr>
        <p:xfrm>
          <a:off x="97725" y="5302682"/>
          <a:ext cx="4646499" cy="144774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3538"/>
                <a:gridCol w="506421"/>
                <a:gridCol w="586109"/>
                <a:gridCol w="524872"/>
                <a:gridCol w="664839"/>
                <a:gridCol w="594856"/>
                <a:gridCol w="594856"/>
                <a:gridCol w="611008"/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R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5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CT+CCRT/R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89693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CCR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65568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CCRT+C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10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417118"/>
              </p:ext>
            </p:extLst>
          </p:nvPr>
        </p:nvGraphicFramePr>
        <p:xfrm>
          <a:off x="6173902" y="5331695"/>
          <a:ext cx="4646499" cy="1127703"/>
        </p:xfrm>
        <a:graphic>
          <a:graphicData uri="http://schemas.openxmlformats.org/drawingml/2006/table">
            <a:tbl>
              <a:tblPr firstRow="1" bandRow="1">
                <a:effectLst/>
                <a:tableStyleId>{5C22544A-7EE6-4342-B048-85BDC9FD1C3A}</a:tableStyleId>
              </a:tblPr>
              <a:tblGrid>
                <a:gridCol w="563538"/>
                <a:gridCol w="506421"/>
                <a:gridCol w="586109"/>
                <a:gridCol w="524872"/>
                <a:gridCol w="664839"/>
                <a:gridCol w="594856"/>
                <a:gridCol w="594856"/>
                <a:gridCol w="611008"/>
              </a:tblGrid>
              <a:tr h="259023">
                <a:tc gridSpan="8">
                  <a:txBody>
                    <a:bodyPr/>
                    <a:lstStyle/>
                    <a:p>
                      <a:pPr algn="l"/>
                      <a:r>
                        <a:rPr lang="en-US" altLang="zh-CN" sz="900" b="1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umber at risk</a:t>
                      </a:r>
                      <a:endParaRPr lang="zh-CN" altLang="en-US" sz="900" b="1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88575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transplan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93057"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Non-transplant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2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94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28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7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9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6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900" b="0" cap="none" spc="0" dirty="0" smtClean="0">
                          <a:ln>
                            <a:noFill/>
                          </a:ln>
                          <a:solidFill>
                            <a:sysClr val="windowText" lastClr="000000"/>
                          </a:solidFill>
                          <a:effectLst/>
                        </a:rPr>
                        <a:t>1</a:t>
                      </a:r>
                      <a:endParaRPr lang="zh-CN" altLang="en-US" sz="900" b="0" cap="none" spc="0" dirty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9" name="文本框 36"/>
          <p:cNvSpPr txBox="1"/>
          <p:nvPr/>
        </p:nvSpPr>
        <p:spPr>
          <a:xfrm>
            <a:off x="97211" y="0"/>
            <a:ext cx="2511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 smtClean="0"/>
              <a:t>Supplementary Figure 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23163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7</TotalTime>
  <Words>483</Words>
  <Application>Microsoft Office PowerPoint</Application>
  <PresentationFormat>宽屏</PresentationFormat>
  <Paragraphs>325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YSUCC</dc:creator>
  <cp:lastModifiedBy>SYSUCC</cp:lastModifiedBy>
  <cp:revision>19</cp:revision>
  <dcterms:created xsi:type="dcterms:W3CDTF">2019-06-24T07:30:00Z</dcterms:created>
  <dcterms:modified xsi:type="dcterms:W3CDTF">2019-12-10T22:17:08Z</dcterms:modified>
</cp:coreProperties>
</file>